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7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6" r:id="rId12"/>
    <p:sldId id="267" r:id="rId13"/>
    <p:sldId id="268" r:id="rId14"/>
    <p:sldId id="269" r:id="rId15"/>
    <p:sldId id="275" r:id="rId16"/>
    <p:sldId id="270" r:id="rId17"/>
    <p:sldId id="271" r:id="rId18"/>
    <p:sldId id="272" r:id="rId19"/>
    <p:sldId id="273" r:id="rId20"/>
    <p:sldId id="274" r:id="rId2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0" d="100"/>
          <a:sy n="120" d="100"/>
        </p:scale>
        <p:origin x="19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2FF926-A2B1-49C8-8828-3A8EDA5F729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F9AC6A0-580D-4A0E-84A9-C0DB3641BF0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BE83ED-0AC7-419D-B6E7-821DCDFE61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703E1-B202-414C-8E5F-3E56430E2BBA}" type="datetimeFigureOut">
              <a:rPr lang="en-US" smtClean="0"/>
              <a:t>5/2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199E76-7A4D-4D0C-B7E1-DBA5748C64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7B7EB2-9D32-46D5-AA01-865EEC9781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55F3A-4EF2-440A-8D5A-0EA05033C8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29421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43C7C4-5C61-4261-BD32-1E7CA1E51C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C26F1D0-3C2C-4499-9CA1-EAA371F1FE7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E08FD6-33C4-4790-967C-DD7B11C0BE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703E1-B202-414C-8E5F-3E56430E2BBA}" type="datetimeFigureOut">
              <a:rPr lang="en-US" smtClean="0"/>
              <a:t>5/2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769AA9-26D0-42BB-95FF-A505DFC1C9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D2B089-766A-408B-96FC-2EB7E110EE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55F3A-4EF2-440A-8D5A-0EA05033C8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77124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768CDD8-B056-4077-83F3-D75FB3DB9B9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F1C6353-A3CA-4C88-BFDB-41383162E2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51C41E-AED4-4BA7-9270-17E543354D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703E1-B202-414C-8E5F-3E56430E2BBA}" type="datetimeFigureOut">
              <a:rPr lang="en-US" smtClean="0"/>
              <a:t>5/2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EFB108-F016-40F9-A84A-5498D51207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E24121-C74D-4B39-8480-4836C0135B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55F3A-4EF2-440A-8D5A-0EA05033C8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78071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F662D1-2B40-48BB-9BA8-CA6863122C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4CAB77-36C3-410C-9635-A7D85EAD3C1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A73661-DCDD-4928-B520-3D8F215E58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703E1-B202-414C-8E5F-3E56430E2BBA}" type="datetimeFigureOut">
              <a:rPr lang="en-US" smtClean="0"/>
              <a:t>5/2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E5EDD7-C221-4E25-83CD-4B8E890A9F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32CE64-1B62-4B6B-9C16-ED923C9DA0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55F3A-4EF2-440A-8D5A-0EA05033C8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74474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3907F9-B683-4CE0-B962-3A789878A9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321C1B4-C8C8-408D-99D0-F9F8B2168B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949A26-E367-4B49-86BA-24BC6AC436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703E1-B202-414C-8E5F-3E56430E2BBA}" type="datetimeFigureOut">
              <a:rPr lang="en-US" smtClean="0"/>
              <a:t>5/2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2DA216-0A68-4477-AADD-31D6154CE0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99036C-2E52-4080-94B2-4707E44A98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55F3A-4EF2-440A-8D5A-0EA05033C8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81317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C712E0-CD41-48F4-990A-50C7339E86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BC0848-CBA9-4527-B385-67DB5258AC7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C54F550-AA49-4413-91AC-A6420E3596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A6FCB2-2C97-441F-B2F4-E8A49A8845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703E1-B202-414C-8E5F-3E56430E2BBA}" type="datetimeFigureOut">
              <a:rPr lang="en-US" smtClean="0"/>
              <a:t>5/2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FB01694-DA48-4466-8699-A083DD1B15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6420E2-7DA9-4B33-9580-80B1FCFB03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55F3A-4EF2-440A-8D5A-0EA05033C8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76176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00A0E0-ABDC-46C3-A2F3-DCB600A6B8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4F220CF-E8D7-4E8A-A46C-EDD3E2A04C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DED1186-0953-4BA5-8DD5-FAF5726C74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90DE4B0-356E-4AD8-8677-44045FE2A07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0864D05-9F49-4884-86A0-C080AD1D968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FC43335-1D8A-44B7-B13C-8598DDF4F1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703E1-B202-414C-8E5F-3E56430E2BBA}" type="datetimeFigureOut">
              <a:rPr lang="en-US" smtClean="0"/>
              <a:t>5/25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8C963C9-4D8C-4CBC-AF5D-9946404329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3543346-47B1-48BF-9A6A-CB90578AD9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55F3A-4EF2-440A-8D5A-0EA05033C8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2708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3ED830-EDA3-4B3B-ACBC-FC10BF07C4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74548A9-4210-45F2-BEB4-2B980D33B4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703E1-B202-414C-8E5F-3E56430E2BBA}" type="datetimeFigureOut">
              <a:rPr lang="en-US" smtClean="0"/>
              <a:t>5/25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C83B752-F217-42D6-A56E-1A3AAE51E2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7F438EC-FB8D-4FB8-8321-6A8B055ED2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55F3A-4EF2-440A-8D5A-0EA05033C8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605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22B2C01-270A-4AC3-85B1-834D3E8B8E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703E1-B202-414C-8E5F-3E56430E2BBA}" type="datetimeFigureOut">
              <a:rPr lang="en-US" smtClean="0"/>
              <a:t>5/25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EA5D715-BDA0-4D92-861A-3678B084F6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91CF444-11C7-473F-A8EF-1FC0798187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55F3A-4EF2-440A-8D5A-0EA05033C8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15553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D23FBB-D01D-46C7-8ED1-E6BE195E3F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6CDFB7-793E-4A3D-9A7A-1B1DF8091BF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DBC9544-6569-44C4-A7CE-451FC94337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C8B2561-16BA-4629-962C-8067F0CA22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703E1-B202-414C-8E5F-3E56430E2BBA}" type="datetimeFigureOut">
              <a:rPr lang="en-US" smtClean="0"/>
              <a:t>5/2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96395A9-12EB-403E-9FCC-E26898A228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9DA7D91-126B-4631-8D77-0D012DD55D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55F3A-4EF2-440A-8D5A-0EA05033C8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77613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4BFAD9-D68D-4ECA-8130-38797CE8FD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2852DEA-5057-418B-8A37-4E019297A0A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E25FE3F-608F-4F26-BC0A-751D77D082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82871B-87C8-4188-8710-FAF81E0DC0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703E1-B202-414C-8E5F-3E56430E2BBA}" type="datetimeFigureOut">
              <a:rPr lang="en-US" smtClean="0"/>
              <a:t>5/2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FB9A76-59F1-4576-A880-F70FB9F818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25002F-FD3A-4629-AB24-941FA1AE1D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55F3A-4EF2-440A-8D5A-0EA05033C8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5726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467B1CB-0BDA-4075-93B3-E9233FAEDB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188F48-5BE1-4B69-88FF-77A208BA0F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6E52AA-2227-46F6-8F34-68687C7876D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7703E1-B202-414C-8E5F-3E56430E2BBA}" type="datetimeFigureOut">
              <a:rPr lang="en-US" smtClean="0"/>
              <a:t>5/2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24AFF7-DEC7-41AA-B1B7-F3263764C7B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9D682B-9A45-4539-B7E0-A8F9CFF2EDD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455F3A-4EF2-440A-8D5A-0EA05033C8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03493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5663F58-9306-4F89-B21F-BB7397C22FF6}"/>
              </a:ext>
            </a:extLst>
          </p:cNvPr>
          <p:cNvSpPr txBox="1"/>
          <p:nvPr/>
        </p:nvSpPr>
        <p:spPr>
          <a:xfrm>
            <a:off x="0" y="0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 </a:t>
            </a:r>
            <a:r>
              <a:rPr 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ar genome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10A77E87-8845-4DCB-9ACE-6BD94F54211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0897" y="429231"/>
            <a:ext cx="10968064" cy="306427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932B3BAB-9F9B-428D-9F83-F4A06EA547B3}"/>
              </a:ext>
            </a:extLst>
          </p:cNvPr>
          <p:cNvSpPr txBox="1"/>
          <p:nvPr/>
        </p:nvSpPr>
        <p:spPr>
          <a:xfrm>
            <a:off x="0" y="6290269"/>
            <a:ext cx="12192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ecular discrimination of Panax ginseng cultivar K-1 using pathogenesis-related protein 5 gene (Wang et al., 2019) 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3C8B0162-CCE4-4AE8-ADD5-0ADC8B23F44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6619" y="3741444"/>
            <a:ext cx="6620799" cy="21720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4985541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0E5828D-A0E0-4BD0-8576-11BC509F6271}"/>
              </a:ext>
            </a:extLst>
          </p:cNvPr>
          <p:cNvSpPr txBox="1"/>
          <p:nvPr/>
        </p:nvSpPr>
        <p:spPr>
          <a:xfrm>
            <a:off x="0" y="6596390"/>
            <a:ext cx="12192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Wingdings" panose="05000000000000000000" pitchFamily="2" charset="2"/>
              <a:buChar char="§"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simple real-time polymerase chain reaction (PCR)-based assay for authentication of the Chinese Panax ginseng cultivar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may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om a local ginseng population (Wang et al., 2010b)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CD90341-9C86-43A7-9001-47AC4BF0F34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9520"/>
            <a:ext cx="5212010" cy="653687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F581BBC-E84B-4731-8B1B-1B14D335656D}"/>
              </a:ext>
            </a:extLst>
          </p:cNvPr>
          <p:cNvSpPr txBox="1"/>
          <p:nvPr/>
        </p:nvSpPr>
        <p:spPr>
          <a:xfrm>
            <a:off x="0" y="0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</a:t>
            </a:r>
            <a:r>
              <a:rPr 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tochondrial genome</a:t>
            </a:r>
          </a:p>
        </p:txBody>
      </p:sp>
    </p:spTree>
    <p:extLst>
      <p:ext uri="{BB962C8B-B14F-4D97-AF65-F5344CB8AC3E}">
        <p14:creationId xmlns:p14="http://schemas.microsoft.com/office/powerpoint/2010/main" val="161398918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1299007-F663-4962-A5CE-ABB6581A7C2D}"/>
              </a:ext>
            </a:extLst>
          </p:cNvPr>
          <p:cNvSpPr txBox="1"/>
          <p:nvPr/>
        </p:nvSpPr>
        <p:spPr>
          <a:xfrm>
            <a:off x="0" y="0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</a:t>
            </a:r>
            <a:r>
              <a:rPr 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bosomal genom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177897B-4E4D-4D0D-9406-91EC1417A49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69332"/>
            <a:ext cx="7066350" cy="547613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E159848-CE48-44AE-A7A7-E6D730361D66}"/>
              </a:ext>
            </a:extLst>
          </p:cNvPr>
          <p:cNvSpPr txBox="1"/>
          <p:nvPr/>
        </p:nvSpPr>
        <p:spPr>
          <a:xfrm>
            <a:off x="0" y="6596390"/>
            <a:ext cx="12192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Wingdings" panose="05000000000000000000" pitchFamily="2" charset="2"/>
              <a:buChar char="§"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velopment of a single-nucleotide-polymorphism marker for specific authentication of Korean ginseng (Panax ginseng Meyer) new cultivar “G-1 (Yang et al., 2017) 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DB09CFA5-15B8-46B7-BB1B-24FAA3FB3F5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6396302" y="1540985"/>
            <a:ext cx="6303697" cy="35910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2746911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46253BD-893F-471D-A065-A440AAC240D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2369" y="554742"/>
            <a:ext cx="11019692" cy="574851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0CD1EF5-FF81-4D1E-A40B-15BD298AC861}"/>
              </a:ext>
            </a:extLst>
          </p:cNvPr>
          <p:cNvSpPr txBox="1"/>
          <p:nvPr/>
        </p:nvSpPr>
        <p:spPr>
          <a:xfrm>
            <a:off x="0" y="6596390"/>
            <a:ext cx="12192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Wingdings" panose="05000000000000000000" pitchFamily="2" charset="2"/>
              <a:buChar char="§"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Simplified Method for Identifying the Panax ginseng Cultivar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umpoong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sed on 26S rDNA (Wang et al., 2010b)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F85FDA5-5FFD-4431-A052-D3A6B6876097}"/>
              </a:ext>
            </a:extLst>
          </p:cNvPr>
          <p:cNvSpPr txBox="1"/>
          <p:nvPr/>
        </p:nvSpPr>
        <p:spPr>
          <a:xfrm>
            <a:off x="0" y="0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</a:t>
            </a:r>
            <a:r>
              <a:rPr 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bosomal genome</a:t>
            </a:r>
          </a:p>
        </p:txBody>
      </p:sp>
    </p:spTree>
    <p:extLst>
      <p:ext uri="{BB962C8B-B14F-4D97-AF65-F5344CB8AC3E}">
        <p14:creationId xmlns:p14="http://schemas.microsoft.com/office/powerpoint/2010/main" val="178817448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7FA9FEC-8564-4AE1-AA84-84D467C2E1BC}"/>
              </a:ext>
            </a:extLst>
          </p:cNvPr>
          <p:cNvSpPr txBox="1"/>
          <p:nvPr/>
        </p:nvSpPr>
        <p:spPr>
          <a:xfrm>
            <a:off x="0" y="6596390"/>
            <a:ext cx="12192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Wingdings" panose="05000000000000000000" pitchFamily="2" charset="2"/>
              <a:buChar char="§"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ecular authentication of Panax ginseng and ginseng products using robust SNP markers in ribosomal external transcribed spacer region (Wang et al., 2011a)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FA89A2B-305A-42FF-8A55-3A89C446587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5414" y="471024"/>
            <a:ext cx="9409723" cy="591595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FC3563A-DAF8-4BA8-BC91-597B048EE165}"/>
              </a:ext>
            </a:extLst>
          </p:cNvPr>
          <p:cNvSpPr txBox="1"/>
          <p:nvPr/>
        </p:nvSpPr>
        <p:spPr>
          <a:xfrm>
            <a:off x="0" y="0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</a:t>
            </a:r>
            <a:r>
              <a:rPr 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bosomal genome</a:t>
            </a:r>
          </a:p>
        </p:txBody>
      </p:sp>
    </p:spTree>
    <p:extLst>
      <p:ext uri="{BB962C8B-B14F-4D97-AF65-F5344CB8AC3E}">
        <p14:creationId xmlns:p14="http://schemas.microsoft.com/office/powerpoint/2010/main" val="355156910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EF98C3D4-025B-4CC6-8526-7E1E6E5D7265}"/>
              </a:ext>
            </a:extLst>
          </p:cNvPr>
          <p:cNvSpPr txBox="1"/>
          <p:nvPr/>
        </p:nvSpPr>
        <p:spPr>
          <a:xfrm>
            <a:off x="0" y="6530926"/>
            <a:ext cx="121920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ecular authentication of ginseng cultivars by comparison of internal transcribed spacer and 5.8S rDNA sequences (Kim et al., 2007)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416AF30-15E8-4C79-AAA1-60299DD19E3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7845" y="327790"/>
            <a:ext cx="6925231" cy="620313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1909D10-BE06-47C8-831C-4BDDD6198CA8}"/>
              </a:ext>
            </a:extLst>
          </p:cNvPr>
          <p:cNvSpPr txBox="1"/>
          <p:nvPr/>
        </p:nvSpPr>
        <p:spPr>
          <a:xfrm>
            <a:off x="0" y="0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</a:t>
            </a:r>
            <a:r>
              <a:rPr 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bosomal genome</a:t>
            </a:r>
          </a:p>
        </p:txBody>
      </p:sp>
    </p:spTree>
    <p:extLst>
      <p:ext uri="{BB962C8B-B14F-4D97-AF65-F5344CB8AC3E}">
        <p14:creationId xmlns:p14="http://schemas.microsoft.com/office/powerpoint/2010/main" val="50645877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EE348E6-5760-4877-976F-9367F855C08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4668723" cy="637297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8EFFF26-812B-4E74-873E-D194606CC83B}"/>
              </a:ext>
            </a:extLst>
          </p:cNvPr>
          <p:cNvSpPr txBox="1"/>
          <p:nvPr/>
        </p:nvSpPr>
        <p:spPr>
          <a:xfrm>
            <a:off x="0" y="6425571"/>
            <a:ext cx="1219200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b="0" i="0" dirty="0" err="1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Osathanunkul</a:t>
            </a:r>
            <a:r>
              <a:rPr lang="en-US" sz="9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, M. and </a:t>
            </a:r>
            <a:r>
              <a:rPr lang="en-US" sz="900" b="0" i="0" dirty="0" err="1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Madesis</a:t>
            </a:r>
            <a:r>
              <a:rPr lang="en-US" sz="9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, P., 2019. Bar-HRM: a reliable and fast method for species identification of ginseng (Panax ginseng, Panax </a:t>
            </a:r>
            <a:r>
              <a:rPr lang="en-US" sz="900" b="0" i="0" dirty="0" err="1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notoginseng</a:t>
            </a:r>
            <a:r>
              <a:rPr lang="en-US" sz="9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, Talinum </a:t>
            </a:r>
            <a:r>
              <a:rPr lang="en-US" sz="900" b="0" i="0" dirty="0" err="1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aniculatum</a:t>
            </a:r>
            <a:r>
              <a:rPr lang="en-US" sz="9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 and Phytolacca Americana). </a:t>
            </a:r>
            <a:r>
              <a:rPr lang="en-US" sz="900" b="0" i="1" dirty="0" err="1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eerJ</a:t>
            </a:r>
            <a:r>
              <a:rPr lang="en-US" sz="9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, </a:t>
            </a:r>
            <a:r>
              <a:rPr lang="en-US" sz="900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7</a:t>
            </a:r>
            <a:r>
              <a:rPr lang="en-US" sz="9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, p.e7660.</a:t>
            </a:r>
            <a:endParaRPr lang="en-US" sz="9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A6D9BD3-C057-4755-8138-E4DDE66F2A20}"/>
              </a:ext>
            </a:extLst>
          </p:cNvPr>
          <p:cNvSpPr txBox="1"/>
          <p:nvPr/>
        </p:nvSpPr>
        <p:spPr>
          <a:xfrm>
            <a:off x="0" y="0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</a:t>
            </a:r>
            <a:r>
              <a:rPr 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bosomal genom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28F3C91-639B-4DB9-BEDB-C24E2049482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835" r="2614"/>
          <a:stretch/>
        </p:blipFill>
        <p:spPr>
          <a:xfrm>
            <a:off x="4485481" y="855914"/>
            <a:ext cx="7576647" cy="42846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312348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E9C10DA-A0BE-4969-BDB1-26687D583AB7}"/>
              </a:ext>
            </a:extLst>
          </p:cNvPr>
          <p:cNvSpPr txBox="1"/>
          <p:nvPr/>
        </p:nvSpPr>
        <p:spPr>
          <a:xfrm>
            <a:off x="0" y="-16417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loroplast genome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8D50680-AEC7-4F28-9B72-6A162DED0475}"/>
              </a:ext>
            </a:extLst>
          </p:cNvPr>
          <p:cNvSpPr txBox="1"/>
          <p:nvPr/>
        </p:nvSpPr>
        <p:spPr>
          <a:xfrm>
            <a:off x="0" y="6596390"/>
            <a:ext cx="12192000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rehensive comparative analysis of chloroplast genomes from seven Panax species and development of an authentication system based on species-unique single nucleotide polymorphism markers (</a:t>
            </a:r>
            <a:r>
              <a:rPr lang="en-U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iang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t al., 2020)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FB8B868-925C-4C5D-BC2C-92D0DF1D1C5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6419" y="321905"/>
            <a:ext cx="8653587" cy="62744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863009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EF06A71-D5A9-4C82-B4A1-8505FFA566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6030" y="498515"/>
            <a:ext cx="11237293" cy="418419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371D526-68A0-435F-B6F2-786C6FEF1B4B}"/>
              </a:ext>
            </a:extLst>
          </p:cNvPr>
          <p:cNvSpPr txBox="1"/>
          <p:nvPr/>
        </p:nvSpPr>
        <p:spPr>
          <a:xfrm>
            <a:off x="0" y="6596390"/>
            <a:ext cx="121920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rehensive Survey of Genetic Diversity in Chloroplast Genomes and 45S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rDNAs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in Panax ginseng Species (Kim et al., 2015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86EE079A-03FB-4530-B3AC-028E0FAD5DC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7888" y="4726291"/>
            <a:ext cx="8494605" cy="182651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AC8C6E2-823D-4BFC-9DCF-2D67A40CE312}"/>
              </a:ext>
            </a:extLst>
          </p:cNvPr>
          <p:cNvSpPr txBox="1"/>
          <p:nvPr/>
        </p:nvSpPr>
        <p:spPr>
          <a:xfrm>
            <a:off x="0" y="-16417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loroplast genome</a:t>
            </a:r>
          </a:p>
        </p:txBody>
      </p:sp>
    </p:spTree>
    <p:extLst>
      <p:ext uri="{BB962C8B-B14F-4D97-AF65-F5344CB8AC3E}">
        <p14:creationId xmlns:p14="http://schemas.microsoft.com/office/powerpoint/2010/main" val="175728334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EB79246-9104-4416-A244-556BF5D9CA77}"/>
              </a:ext>
            </a:extLst>
          </p:cNvPr>
          <p:cNvSpPr txBox="1"/>
          <p:nvPr/>
        </p:nvSpPr>
        <p:spPr>
          <a:xfrm>
            <a:off x="0" y="6189990"/>
            <a:ext cx="121920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thentication markers for five major Panax species developed via comparative analysis of complete chloroplast genome sequences (Nguyen et al., 2017)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F76800EE-AFD2-4F0F-B112-25F8B3472F6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2154" y="528965"/>
            <a:ext cx="9300307" cy="555304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3CBD6BA-9A73-4CF2-8A98-CE7952159173}"/>
              </a:ext>
            </a:extLst>
          </p:cNvPr>
          <p:cNvSpPr txBox="1"/>
          <p:nvPr/>
        </p:nvSpPr>
        <p:spPr>
          <a:xfrm>
            <a:off x="0" y="-16417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loroplast genome</a:t>
            </a:r>
          </a:p>
        </p:txBody>
      </p:sp>
    </p:spTree>
    <p:extLst>
      <p:ext uri="{BB962C8B-B14F-4D97-AF65-F5344CB8AC3E}">
        <p14:creationId xmlns:p14="http://schemas.microsoft.com/office/powerpoint/2010/main" val="306303376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6CD2C91-0C34-434C-A615-4E900CB418EF}"/>
              </a:ext>
            </a:extLst>
          </p:cNvPr>
          <p:cNvSpPr txBox="1"/>
          <p:nvPr/>
        </p:nvSpPr>
        <p:spPr>
          <a:xfrm>
            <a:off x="0" y="-16417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loroplast genom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A28650F-97FE-4FBC-97DE-ADD1F9BB716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52915"/>
            <a:ext cx="7395615" cy="589658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5A4EB82-6A73-4B9B-BC93-FD77E927F2EC}"/>
              </a:ext>
            </a:extLst>
          </p:cNvPr>
          <p:cNvSpPr txBox="1"/>
          <p:nvPr/>
        </p:nvSpPr>
        <p:spPr>
          <a:xfrm>
            <a:off x="0" y="6503414"/>
            <a:ext cx="1168400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Manzanilla, V., Kool, A., Nguyen </a:t>
            </a:r>
            <a:r>
              <a:rPr lang="en-US" sz="900" b="0" i="0" dirty="0" err="1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Nhat</a:t>
            </a:r>
            <a:r>
              <a:rPr lang="en-US" sz="9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, L., Nong Van, H., Le </a:t>
            </a:r>
            <a:r>
              <a:rPr lang="en-US" sz="900" b="0" i="0" dirty="0" err="1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Thi</a:t>
            </a:r>
            <a:r>
              <a:rPr lang="en-US" sz="9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 Thu, H. and De Boer, H.J., 2018. </a:t>
            </a:r>
            <a:r>
              <a:rPr lang="en-US" sz="900" b="0" i="0" dirty="0" err="1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hylogenomics</a:t>
            </a:r>
            <a:r>
              <a:rPr lang="en-US" sz="9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 and barcoding of Panax: toward the identification of ginseng species. </a:t>
            </a:r>
            <a:r>
              <a:rPr lang="en-US" sz="900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BMC evolutionary biology</a:t>
            </a:r>
            <a:r>
              <a:rPr lang="en-US" sz="9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, </a:t>
            </a:r>
            <a:r>
              <a:rPr lang="en-US" sz="900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18</a:t>
            </a:r>
            <a:r>
              <a:rPr lang="en-US" sz="9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(1), pp.1-14.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29410510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386F39A-F228-4F4E-BA55-133CD4914E8F}"/>
              </a:ext>
            </a:extLst>
          </p:cNvPr>
          <p:cNvSpPr txBox="1"/>
          <p:nvPr/>
        </p:nvSpPr>
        <p:spPr>
          <a:xfrm>
            <a:off x="0" y="0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 </a:t>
            </a:r>
            <a:r>
              <a:rPr 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ar genome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60A743EC-5E95-477E-992E-20FDEDA8F2E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69332"/>
            <a:ext cx="5658338" cy="3179189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76685431-ABAB-4E91-A2B5-256F1B9F9E0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7517954" y="2398342"/>
            <a:ext cx="6860479" cy="2063798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7A03F689-D9BA-4016-986C-2F657B7A34F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368594" y="527088"/>
            <a:ext cx="4455344" cy="5664827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90C45158-5081-4A50-B4AC-93C82331A9D5}"/>
              </a:ext>
            </a:extLst>
          </p:cNvPr>
          <p:cNvSpPr txBox="1"/>
          <p:nvPr/>
        </p:nvSpPr>
        <p:spPr>
          <a:xfrm>
            <a:off x="0" y="6627168"/>
            <a:ext cx="10496777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0" i="0" dirty="0" err="1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Grazina</a:t>
            </a:r>
            <a:r>
              <a:rPr lang="en-US" sz="8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, L., Amaral, J.S., Costa, J. and </a:t>
            </a:r>
            <a:r>
              <a:rPr lang="en-US" sz="800" b="0" i="0" dirty="0" err="1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Mafra</a:t>
            </a:r>
            <a:r>
              <a:rPr lang="en-US" sz="8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, I., 2021. Towards authentication of Korean ginseng-containing foods: Differentiation of five Panax species by a novel diagnostic tool. </a:t>
            </a:r>
            <a:r>
              <a:rPr lang="en-US" sz="800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LWT</a:t>
            </a:r>
            <a:r>
              <a:rPr lang="en-US" sz="8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, </a:t>
            </a:r>
            <a:r>
              <a:rPr lang="en-US" sz="800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151</a:t>
            </a:r>
            <a:r>
              <a:rPr lang="en-US" sz="8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, p.112211.</a:t>
            </a:r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3947829277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865F1E0-7F0B-4451-B6FF-BDADC2F32E15}"/>
              </a:ext>
            </a:extLst>
          </p:cNvPr>
          <p:cNvSpPr txBox="1"/>
          <p:nvPr/>
        </p:nvSpPr>
        <p:spPr>
          <a:xfrm>
            <a:off x="0" y="-16417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loroplast genome</a:t>
            </a:r>
          </a:p>
        </p:txBody>
      </p:sp>
    </p:spTree>
    <p:extLst>
      <p:ext uri="{BB962C8B-B14F-4D97-AF65-F5344CB8AC3E}">
        <p14:creationId xmlns:p14="http://schemas.microsoft.com/office/powerpoint/2010/main" val="32573244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99E3F94-5417-4DEF-9E65-5240CEC75BB9}"/>
              </a:ext>
            </a:extLst>
          </p:cNvPr>
          <p:cNvSpPr txBox="1"/>
          <p:nvPr/>
        </p:nvSpPr>
        <p:spPr>
          <a:xfrm>
            <a:off x="0" y="6442501"/>
            <a:ext cx="12192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Wingdings" panose="05000000000000000000" pitchFamily="2" charset="2"/>
              <a:buChar char="§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crimination of Korean ginseng (Panax ginseng Meyer) cultiva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unpoon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American ginseng (Panax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uinquefoliu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using the auxin repressed protein gene (Kim et al., 2016) 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53E3F093-8E46-4757-9FDE-21D3F458F7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16183"/>
            <a:ext cx="7404669" cy="5825633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912822F1-A06F-4911-89FB-4F93795CF0D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7757688" y="2437261"/>
            <a:ext cx="6368475" cy="164200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BE7334B-37DC-4381-8145-78148FA17558}"/>
              </a:ext>
            </a:extLst>
          </p:cNvPr>
          <p:cNvSpPr txBox="1"/>
          <p:nvPr/>
        </p:nvSpPr>
        <p:spPr>
          <a:xfrm>
            <a:off x="0" y="0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 </a:t>
            </a:r>
            <a:r>
              <a:rPr 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ar genome</a:t>
            </a:r>
          </a:p>
        </p:txBody>
      </p:sp>
    </p:spTree>
    <p:extLst>
      <p:ext uri="{BB962C8B-B14F-4D97-AF65-F5344CB8AC3E}">
        <p14:creationId xmlns:p14="http://schemas.microsoft.com/office/powerpoint/2010/main" val="9819511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34246AF-2FF1-49DD-A495-E3A6E43BF719}"/>
              </a:ext>
            </a:extLst>
          </p:cNvPr>
          <p:cNvSpPr txBox="1"/>
          <p:nvPr/>
        </p:nvSpPr>
        <p:spPr>
          <a:xfrm>
            <a:off x="0" y="4666030"/>
            <a:ext cx="12192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Wingdings" panose="05000000000000000000" pitchFamily="2" charset="2"/>
              <a:buChar char="§"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velopment of Molecular Markers for the Determination of the New Cultivar ‘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unpoong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 in Panax ginseng C. A. MEYER Associated with a Major Latex-Like Protein Gene (Sun et al., 2010)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25CEF1F-38DF-4925-A997-91EE4D347D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1599" y="719016"/>
            <a:ext cx="8022235" cy="366460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F64AC9C-9842-4727-A6DA-D969201B3A98}"/>
              </a:ext>
            </a:extLst>
          </p:cNvPr>
          <p:cNvSpPr txBox="1"/>
          <p:nvPr/>
        </p:nvSpPr>
        <p:spPr>
          <a:xfrm>
            <a:off x="0" y="0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 </a:t>
            </a:r>
            <a:r>
              <a:rPr 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ar genome</a:t>
            </a:r>
          </a:p>
        </p:txBody>
      </p:sp>
    </p:spTree>
    <p:extLst>
      <p:ext uri="{BB962C8B-B14F-4D97-AF65-F5344CB8AC3E}">
        <p14:creationId xmlns:p14="http://schemas.microsoft.com/office/powerpoint/2010/main" val="1713833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F9FB135-C24D-4D17-AB93-E78F2F1057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1015" y="102383"/>
            <a:ext cx="4642338" cy="639162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E817FEF-4ED3-43C4-A0EA-3C6B85D5B112}"/>
              </a:ext>
            </a:extLst>
          </p:cNvPr>
          <p:cNvSpPr txBox="1"/>
          <p:nvPr/>
        </p:nvSpPr>
        <p:spPr>
          <a:xfrm>
            <a:off x="0" y="6596390"/>
            <a:ext cx="12192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Wingdings" panose="05000000000000000000" pitchFamily="2" charset="2"/>
              <a:buChar char="§"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vel SNP markers on ginsenosides biosynthesis functional gene for authentication of ginseng herbs and commercial products (Wen-Ru et al., 2020) 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2EFC473-60E2-4762-86D3-05F2BD479EE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77973" y="1189455"/>
            <a:ext cx="6076181" cy="520216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204CA1D-0B54-42BA-A8F8-AE42F79B1E6E}"/>
              </a:ext>
            </a:extLst>
          </p:cNvPr>
          <p:cNvSpPr txBox="1"/>
          <p:nvPr/>
        </p:nvSpPr>
        <p:spPr>
          <a:xfrm>
            <a:off x="0" y="0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 </a:t>
            </a:r>
            <a:r>
              <a:rPr 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ar genome</a:t>
            </a:r>
          </a:p>
        </p:txBody>
      </p:sp>
    </p:spTree>
    <p:extLst>
      <p:ext uri="{BB962C8B-B14F-4D97-AF65-F5344CB8AC3E}">
        <p14:creationId xmlns:p14="http://schemas.microsoft.com/office/powerpoint/2010/main" val="339393463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E924946-1EB8-4517-AE66-D84331502677}"/>
              </a:ext>
            </a:extLst>
          </p:cNvPr>
          <p:cNvSpPr txBox="1"/>
          <p:nvPr/>
        </p:nvSpPr>
        <p:spPr>
          <a:xfrm>
            <a:off x="0" y="0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</a:t>
            </a:r>
            <a:r>
              <a:rPr 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tochondrial genome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735DF5B-F854-4184-B0D8-73CE91DE4DB5}"/>
              </a:ext>
            </a:extLst>
          </p:cNvPr>
          <p:cNvSpPr txBox="1"/>
          <p:nvPr/>
        </p:nvSpPr>
        <p:spPr>
          <a:xfrm>
            <a:off x="0" y="5137139"/>
            <a:ext cx="12192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Wingdings" panose="05000000000000000000" pitchFamily="2" charset="2"/>
              <a:buChar char="§"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ecular identification of the Korean ginseng cultivar “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unpoong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” using the mitochondrial nad7 intron 4 region  (Wang et al., 2009)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64C4677-131E-4DF0-B5BF-A755E103B7A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69332"/>
            <a:ext cx="12192000" cy="43984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3265745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CA7D474-C2B2-4762-976B-A792D937EAA8}"/>
              </a:ext>
            </a:extLst>
          </p:cNvPr>
          <p:cNvSpPr txBox="1"/>
          <p:nvPr/>
        </p:nvSpPr>
        <p:spPr>
          <a:xfrm>
            <a:off x="0" y="5129325"/>
            <a:ext cx="12192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Wingdings" panose="05000000000000000000" pitchFamily="2" charset="2"/>
              <a:buChar char="§"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ecular differentiation of Russian wild ginseng using mitochondrial nad7 intron 3 region (Li et al., 2017)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DFE97A3-DBFA-4434-9287-55DC11C703C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951523"/>
            <a:ext cx="12192000" cy="396365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EA54864-ED21-4EE8-BDCB-B261A70755B3}"/>
              </a:ext>
            </a:extLst>
          </p:cNvPr>
          <p:cNvSpPr txBox="1"/>
          <p:nvPr/>
        </p:nvSpPr>
        <p:spPr>
          <a:xfrm>
            <a:off x="0" y="0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</a:t>
            </a:r>
            <a:r>
              <a:rPr 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tochondrial genome</a:t>
            </a:r>
          </a:p>
        </p:txBody>
      </p:sp>
    </p:spTree>
    <p:extLst>
      <p:ext uri="{BB962C8B-B14F-4D97-AF65-F5344CB8AC3E}">
        <p14:creationId xmlns:p14="http://schemas.microsoft.com/office/powerpoint/2010/main" val="271356406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FEE049B-EADD-475E-88E5-8E9F1BB5F8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31840" y="481311"/>
            <a:ext cx="7862436" cy="518727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98AF45E-9B63-4907-928A-F7A3C15D194C}"/>
              </a:ext>
            </a:extLst>
          </p:cNvPr>
          <p:cNvSpPr txBox="1"/>
          <p:nvPr/>
        </p:nvSpPr>
        <p:spPr>
          <a:xfrm>
            <a:off x="0" y="5668586"/>
            <a:ext cx="12192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Wingdings" panose="05000000000000000000" pitchFamily="2" charset="2"/>
              <a:buChar char="§"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velopment of a multiplex amplification refractory mutation system for simultaneous authentication of Korean ginseng cultivars “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umpoong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” and “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ungsun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” (Wang et al., 2011b)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A49FBF3-5674-43A3-83EF-9B14995ED922}"/>
              </a:ext>
            </a:extLst>
          </p:cNvPr>
          <p:cNvSpPr txBox="1"/>
          <p:nvPr/>
        </p:nvSpPr>
        <p:spPr>
          <a:xfrm>
            <a:off x="0" y="0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</a:t>
            </a:r>
            <a:r>
              <a:rPr 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tochondrial genome</a:t>
            </a:r>
          </a:p>
        </p:txBody>
      </p:sp>
    </p:spTree>
    <p:extLst>
      <p:ext uri="{BB962C8B-B14F-4D97-AF65-F5344CB8AC3E}">
        <p14:creationId xmlns:p14="http://schemas.microsoft.com/office/powerpoint/2010/main" val="301812909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CA50226-D6D3-49A4-9D10-B711B0A1F414}"/>
              </a:ext>
            </a:extLst>
          </p:cNvPr>
          <p:cNvSpPr txBox="1"/>
          <p:nvPr/>
        </p:nvSpPr>
        <p:spPr>
          <a:xfrm>
            <a:off x="0" y="6247701"/>
            <a:ext cx="12192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Wingdings" panose="05000000000000000000" pitchFamily="2" charset="2"/>
              <a:buChar char="§"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PCR-based SNP marker for specific authentication of Korean ginseng (panax ginseng) cultivar ‘‘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unpoong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’ (Wang et al., 2010a)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40461B5-79C5-42CD-904C-D04D77CF0B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8463" y="406400"/>
            <a:ext cx="10935074" cy="584130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294AB6B-3089-4D02-A4E1-68F8DA3701D3}"/>
              </a:ext>
            </a:extLst>
          </p:cNvPr>
          <p:cNvSpPr txBox="1"/>
          <p:nvPr/>
        </p:nvSpPr>
        <p:spPr>
          <a:xfrm>
            <a:off x="0" y="0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</a:t>
            </a:r>
            <a:r>
              <a:rPr lang="en-US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tochondrial genome</a:t>
            </a:r>
          </a:p>
        </p:txBody>
      </p:sp>
    </p:spTree>
    <p:extLst>
      <p:ext uri="{BB962C8B-B14F-4D97-AF65-F5344CB8AC3E}">
        <p14:creationId xmlns:p14="http://schemas.microsoft.com/office/powerpoint/2010/main" val="39352767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188</TotalTime>
  <Words>611</Words>
  <Application>Microsoft Office PowerPoint</Application>
  <PresentationFormat>Widescreen</PresentationFormat>
  <Paragraphs>39</Paragraphs>
  <Slides>2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0</vt:i4>
      </vt:variant>
    </vt:vector>
  </HeadingPairs>
  <TitlesOfParts>
    <vt:vector size="26" baseType="lpstr">
      <vt:lpstr>Arial</vt:lpstr>
      <vt:lpstr>Calibri</vt:lpstr>
      <vt:lpstr>Calibri Light</vt:lpstr>
      <vt:lpstr>Times New Roman</vt:lpstr>
      <vt:lpstr>Wingdings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wais Kazmi</dc:creator>
  <cp:lastModifiedBy>Awais Kazmi</cp:lastModifiedBy>
  <cp:revision>86</cp:revision>
  <dcterms:created xsi:type="dcterms:W3CDTF">2022-05-06T07:31:02Z</dcterms:created>
  <dcterms:modified xsi:type="dcterms:W3CDTF">2022-05-25T09:33:47Z</dcterms:modified>
</cp:coreProperties>
</file>